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>
      <p:cViewPr varScale="1">
        <p:scale>
          <a:sx n="120" d="100"/>
          <a:sy n="120" d="100"/>
        </p:scale>
        <p:origin x="208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00FB22-EC1E-E606-4501-8205D5BFF2B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90F6925-8F14-BEC6-F5C7-6EC04C387EE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045862-964E-80EE-FA14-549FC8E8D8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BB058-D7D6-1E4E-ACAE-7717951422F2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E4C8E0-627C-CA30-D21C-1BE10FE5F9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66C1B5-F04E-4877-CD5F-85BA105E7C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05AFF-EA72-FC4F-92A9-CBD7BD9B4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83024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40F9E3-01BA-CC54-DEB4-4492D60945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BB1656E-A70C-191A-0357-1DE09DB0E0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DCD06F-C39D-B5F8-5C1F-F8035CCD6E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BB058-D7D6-1E4E-ACAE-7717951422F2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E237B5-D50B-AC2C-B44E-B8DAAF24F7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C1033F-9EBF-A9DB-B06E-1F6F7F9AD4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05AFF-EA72-FC4F-92A9-CBD7BD9B4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79692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3C1271B-EA57-0F5E-5039-7E91EF0547C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38BC847-2EDB-8BEE-77CB-7780203039F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6DEC0E-C620-576B-10C6-E653C40662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BB058-D7D6-1E4E-ACAE-7717951422F2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1B9593-1D9A-9879-7D20-C7C716273B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20393F-215D-AE83-7EA2-1689481080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05AFF-EA72-FC4F-92A9-CBD7BD9B4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45652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3EC566-B977-C7A3-623E-EE96C87860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8580EB-8C24-7B9A-0F79-876E357BF2D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A75DED-A5FE-A9BD-DEEF-B2DAE58267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BB058-D7D6-1E4E-ACAE-7717951422F2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46876F-933B-81FE-E1EA-46B6EBCFBF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C6ECCE-5A3F-C048-5627-02C7F38AC5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05AFF-EA72-FC4F-92A9-CBD7BD9B4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61839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8C5506-0493-0368-222A-A46A2ACD78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85412B-E65D-4156-AF49-D9329C1580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A5DB46-5BC5-320D-E696-5B510996C6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BB058-D7D6-1E4E-ACAE-7717951422F2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B89B42-45AA-09CE-F25A-188D71949A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AA7004-2440-8367-B097-52577322A0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05AFF-EA72-FC4F-92A9-CBD7BD9B4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4766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BE345B-8EB5-4FDF-406D-D5BCE2C895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4E16BF1-244A-C913-42D9-21551C50E2F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C5FFAFC-8009-E740-8AAF-79DB9B7EC9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2569A0-67D5-5127-5F62-A2B523FB2B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BB058-D7D6-1E4E-ACAE-7717951422F2}" type="datetimeFigureOut">
              <a:rPr lang="en-US" smtClean="0"/>
              <a:t>2/19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E656812-6369-A2A7-FAE1-6DF0B3D30F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6DEF30-F7A4-C41B-C954-FB01F3F96B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05AFF-EA72-FC4F-92A9-CBD7BD9B4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034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03C3DD-8225-FC4C-CF01-6977612A68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EB43C10-2027-F44A-DAB0-0013E60D72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CD783D4-2EFB-F716-60AB-1CC66BA1247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5F5F1C4-94DF-432D-5878-7336E8A5ACF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3A42F89-57D4-6F85-C87D-AFFBE866F88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545BF7B-354B-7518-C877-5EE58F7846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BB058-D7D6-1E4E-ACAE-7717951422F2}" type="datetimeFigureOut">
              <a:rPr lang="en-US" smtClean="0"/>
              <a:t>2/19/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571440C-1EA1-876C-FFF6-5C054F6408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2E07908-8249-BD7D-0612-5291EE67C2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05AFF-EA72-FC4F-92A9-CBD7BD9B4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75764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F7937D-8D38-AC15-7558-D8CB5D17FE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E114062-8ED1-C595-447A-58F5B7305C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BB058-D7D6-1E4E-ACAE-7717951422F2}" type="datetimeFigureOut">
              <a:rPr lang="en-US" smtClean="0"/>
              <a:t>2/19/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EC13516-C366-C304-478D-FF15AA5294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58540A6-1411-A0FD-5F4F-7C5F832A10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05AFF-EA72-FC4F-92A9-CBD7BD9B4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50921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B1DA46A-8DFD-4C20-52D9-EEBC30F9F2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BB058-D7D6-1E4E-ACAE-7717951422F2}" type="datetimeFigureOut">
              <a:rPr lang="en-US" smtClean="0"/>
              <a:t>2/19/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4CB7C25-D126-9FDF-5E2A-9D5618F616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69DC128-EA51-5788-DB8F-AB81DFE3B2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05AFF-EA72-FC4F-92A9-CBD7BD9B4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31403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065DE7-9BD8-AE2B-61F4-FA735644B3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F2B5659-8DA4-5517-581D-8970AC3E966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DE66693-C24F-FE83-7592-FE8F994DE7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9E2B15-0841-A677-AC9A-8ED0DE45AE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BB058-D7D6-1E4E-ACAE-7717951422F2}" type="datetimeFigureOut">
              <a:rPr lang="en-US" smtClean="0"/>
              <a:t>2/19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B2BAEA5-8002-70B6-C4CD-C495B460EC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19C71E6-CB70-9705-DAD8-D0B67537BE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05AFF-EA72-FC4F-92A9-CBD7BD9B4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2049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E91D29-D0EA-B182-16E3-90DBC312B7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58E8756-EDCC-CA27-B670-FC2EC8BBCF9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9A08372-F959-5FF8-AD74-D6C2DCA3014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59FC5E-908E-61FE-93DA-E2E6B1E2E4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BB058-D7D6-1E4E-ACAE-7717951422F2}" type="datetimeFigureOut">
              <a:rPr lang="en-US" smtClean="0"/>
              <a:t>2/19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692EAD1-D8E5-3F9A-6B55-92E57A4CEF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868504-4446-1EDA-8D8F-968B13795F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05AFF-EA72-FC4F-92A9-CBD7BD9B4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42316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7AE72BD-D448-19EF-5AAF-53587EA295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03FB612-3089-6A0F-5925-A3A5D001BA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02787B-3403-67B2-A4EC-49D23B0F874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4EBB058-D7D6-1E4E-ACAE-7717951422F2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1708BA-4EF5-9611-FFB7-7BF3FCD310E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EF52B5-825A-FF2F-BFCB-1E7340081D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5005AFF-EA72-FC4F-92A9-CBD7BD9B4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45925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1FF3BA4A-1819-9A8A-EB92-273B1326D54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1836" y="0"/>
            <a:ext cx="11768328" cy="408622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D55D2F6-4262-134C-35BE-EDB422224D78}"/>
              </a:ext>
            </a:extLst>
          </p:cNvPr>
          <p:cNvSpPr txBox="1"/>
          <p:nvPr/>
        </p:nvSpPr>
        <p:spPr>
          <a:xfrm>
            <a:off x="211836" y="4086225"/>
            <a:ext cx="11768328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 fontAlgn="base">
              <a:buNone/>
            </a:pPr>
            <a:r>
              <a:rPr lang="en-US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Figure S1</a:t>
            </a:r>
            <a:r>
              <a:rPr lang="en-US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: </a:t>
            </a:r>
            <a:r>
              <a:rPr lang="en-US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Mutation enrichment in the VH library after panning.</a:t>
            </a:r>
            <a:r>
              <a:rPr lang="en-US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 (A) Fold-change </a:t>
            </a:r>
            <a:r>
              <a:rPr lang="en-US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in the frequency of next-generation sequencing </a:t>
            </a:r>
            <a:r>
              <a:rPr lang="en-US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reads </a:t>
            </a:r>
            <a:r>
              <a:rPr lang="en-US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for variant mutations at each VH site of hFlex3a2_v2 </a:t>
            </a:r>
            <a:r>
              <a:rPr lang="en-US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after two rounds of panning, relative to their frequency in the input library. (B) </a:t>
            </a:r>
            <a:r>
              <a:rPr lang="en-US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log10 enrichment of variants in the VH library after two rounds of panning against </a:t>
            </a:r>
            <a:r>
              <a:rPr lang="en-US" i="1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S. flexneri </a:t>
            </a:r>
            <a:r>
              <a:rPr lang="en-US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3a and </a:t>
            </a:r>
            <a:r>
              <a:rPr lang="en-US" i="1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S. </a:t>
            </a:r>
            <a:r>
              <a:rPr lang="en-US" i="1" dirty="0" err="1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sonnei</a:t>
            </a:r>
            <a:r>
              <a:rPr lang="en-US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. Dotted line is 20 standard deviations above the mean mutation enrichment in the input library and indicates a stringent threshold set to distinguish bacteria-mediated enrichment from background variability. </a:t>
            </a:r>
            <a:endParaRPr lang="en-US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67411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4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ayden Schmidt</dc:creator>
  <cp:lastModifiedBy>Hayden Schmidt</cp:lastModifiedBy>
  <cp:revision>1</cp:revision>
  <dcterms:created xsi:type="dcterms:W3CDTF">2026-02-19T23:44:39Z</dcterms:created>
  <dcterms:modified xsi:type="dcterms:W3CDTF">2026-02-19T23:44:57Z</dcterms:modified>
</cp:coreProperties>
</file>